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96A409-3DCF-43BA-889F-769E123DB14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3F54B0-BDD9-4F71-B4D7-25EDDD6CD3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224D56-4F61-402B-BB09-0F6CEBAF590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1635DA-08C4-429E-BB4D-8B5A1984D63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5AE4C8-F346-4192-B72B-E57356DDF7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3D057E-86D5-4516-B89B-D0F2709284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FE65AE-5EA7-4148-B6B6-E2578E84F0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2C8B77-D0FF-444A-8A7C-A5603EE92D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40F1EA-A1CD-49B1-BA60-E0EADA7441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BD9B2A-6023-441B-B334-2F3527F000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BCAC91-693A-4689-A3DC-9EA037266D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E762CB-1F93-4627-B540-A4E8D354B8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6EC1E5-8059-4904-8EF8-47500B1C59C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328320" y="47628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Fig.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116000" y="981000"/>
          <a:ext cx="7201080" cy="3672000"/>
        </p:xfrm>
        <a:graphic>
          <a:graphicData uri="http://schemas.openxmlformats.org/drawingml/2006/table">
            <a:tbl>
              <a:tblPr/>
              <a:tblGrid>
                <a:gridCol w="504720"/>
                <a:gridCol w="196920"/>
                <a:gridCol w="1076400"/>
                <a:gridCol w="1085760"/>
                <a:gridCol w="1087560"/>
                <a:gridCol w="1074600"/>
                <a:gridCol w="1087560"/>
                <a:gridCol w="1087560"/>
              </a:tblGrid>
              <a:tr h="197640"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late 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G 25.82 in        1 mL BG11 + 1 mL BG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G 25.82 in       1 mL BG11 + 1 mL 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G 25.82 in       1 mL BG11 + 1 mL BUZ 2 in 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G 25.82 in 1mL BG11 + 1 mL BUZ 3 in 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7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87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57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7640"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late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G 25.82 in       1 mL BG11 + BUZ 2 (1 mL washed in BG1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G 35.82 in       1 mL BG11 + BUZ 3 (1 mL washed in BG1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G 25.82 in        1 mL BG11 + 1 mL BUZ 2 supernatant in 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G 25.82 in       1 mL BG11 + 1 mL BUZ 3 supernatant in 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8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38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00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29680"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late 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UZ 2 in 1 mL  SM + 1 mL 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UZ 2 in 1 mL SM + 1 mL BG1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UZ 3 in 1 mL SM + 1 mL 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UZ 3 in 1 mL SM + 1 mL BG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8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87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7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13480"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late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UZ 2 (1 mL washed in BG11) + 1 mL BG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UZ 2 in 1 mL SM + 1 mL SAG 25.82 supernatant in BG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UZ 2 (1 mL washed in BG11) + 1 mL SAG 25.82 supernatant in BG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UZ 3 (1 mL washed in BG11) + 1 mL BG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UZ 3 in 1 mL SM + 1 mL SAG 25.82 supernatant in BG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4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UZ 3 (1 mL washed in BG11) + 1 mL SAG 25.82 supernatant in BG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7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239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466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43" name="Rectangle 6"/>
          <p:cNvSpPr/>
          <p:nvPr/>
        </p:nvSpPr>
        <p:spPr>
          <a:xfrm>
            <a:off x="0" y="0"/>
            <a:ext cx="9144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17T15:35:00Z</dcterms:created>
  <dc:creator>miro</dc:creator>
  <dc:description/>
  <dc:language>en-US</dc:language>
  <cp:lastModifiedBy>miro</cp:lastModifiedBy>
  <dcterms:modified xsi:type="dcterms:W3CDTF">2011-08-13T15:48:31Z</dcterms:modified>
  <cp:revision>83</cp:revision>
  <dc:subject/>
  <dc:title>Slide 1</dc:title>
</cp:coreProperties>
</file>